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88825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3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6"/>
  </p:normalViewPr>
  <p:slideViewPr>
    <p:cSldViewPr snapToGrid="0" snapToObjects="1">
      <p:cViewPr varScale="1">
        <p:scale>
          <a:sx n="108" d="100"/>
          <a:sy n="108" d="100"/>
        </p:scale>
        <p:origin x="736" y="192"/>
      </p:cViewPr>
      <p:guideLst>
        <p:guide orient="horz" pos="2160"/>
        <p:guide pos="383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eilobrien:Desktop:Other%20Pharma%20Projects:Novartis:In%20Vivo%20Palbo%20Res%20Models:EFM-19%20Palbo%20Res%20In%20Vivo:EFM_19_PR_LCY_(1_26_2016)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neilobrien:Desktop:Other%20Pharma%20Projects:Novartis:In%20Vivo%20Palbo%20Res%20Models:EFM-19%20Palbo%20Res%20In%20Vivo:EFM_19_PR_LCY_(1_26_2016)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2.2946964031730702E-2"/>
          <c:y val="4.1009463722397499E-2"/>
          <c:w val="0.51419360987697804"/>
          <c:h val="0.86745522740256797"/>
        </c:manualLayout>
      </c:layout>
      <c:scatterChart>
        <c:scatterStyle val="lineMarker"/>
        <c:varyColors val="0"/>
        <c:ser>
          <c:idx val="0"/>
          <c:order val="0"/>
          <c:tx>
            <c:strRef>
              <c:f>'DI TV'!$B$39</c:f>
              <c:strCache>
                <c:ptCount val="1"/>
                <c:pt idx="0">
                  <c:v>EFM19 Vehicle Control</c:v>
                </c:pt>
              </c:strCache>
            </c:strRef>
          </c:tx>
          <c:spPr>
            <a:ln w="19050" cmpd="sng">
              <a:solidFill>
                <a:srgbClr val="000000"/>
              </a:solidFill>
            </a:ln>
          </c:spPr>
          <c:marker>
            <c:spPr>
              <a:solidFill>
                <a:schemeClr val="tx1"/>
              </a:solidFill>
              <a:ln w="19050" cmpd="sng">
                <a:solidFill>
                  <a:srgbClr val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I TV'!$C$49:$P$49</c:f>
                <c:numCache>
                  <c:formatCode>General</c:formatCode>
                  <c:ptCount val="14"/>
                  <c:pt idx="0">
                    <c:v>30.86175611457336</c:v>
                  </c:pt>
                  <c:pt idx="1">
                    <c:v>59.905274574623661</c:v>
                  </c:pt>
                  <c:pt idx="2">
                    <c:v>67.034851108101506</c:v>
                  </c:pt>
                  <c:pt idx="3">
                    <c:v>79.45469665729685</c:v>
                  </c:pt>
                  <c:pt idx="4">
                    <c:v>104.7957374412256</c:v>
                  </c:pt>
                  <c:pt idx="5">
                    <c:v>95.43963677320167</c:v>
                  </c:pt>
                  <c:pt idx="6">
                    <c:v>112.94451373483849</c:v>
                  </c:pt>
                  <c:pt idx="7">
                    <c:v>111.1607585054345</c:v>
                  </c:pt>
                  <c:pt idx="8">
                    <c:v>64.193522427702604</c:v>
                  </c:pt>
                  <c:pt idx="9">
                    <c:v>102.8631182095332</c:v>
                  </c:pt>
                  <c:pt idx="10">
                    <c:v>148.8742236289832</c:v>
                  </c:pt>
                  <c:pt idx="11">
                    <c:v>144.20729412034339</c:v>
                  </c:pt>
                  <c:pt idx="12">
                    <c:v>151.64602788060139</c:v>
                  </c:pt>
                  <c:pt idx="13">
                    <c:v>162.05026433286321</c:v>
                  </c:pt>
                </c:numCache>
              </c:numRef>
            </c:plus>
            <c:minus>
              <c:numRef>
                <c:f>'DI TV'!$C$49:$P$49</c:f>
                <c:numCache>
                  <c:formatCode>General</c:formatCode>
                  <c:ptCount val="14"/>
                  <c:pt idx="0">
                    <c:v>30.86175611457336</c:v>
                  </c:pt>
                  <c:pt idx="1">
                    <c:v>59.905274574623661</c:v>
                  </c:pt>
                  <c:pt idx="2">
                    <c:v>67.034851108101506</c:v>
                  </c:pt>
                  <c:pt idx="3">
                    <c:v>79.45469665729685</c:v>
                  </c:pt>
                  <c:pt idx="4">
                    <c:v>104.7957374412256</c:v>
                  </c:pt>
                  <c:pt idx="5">
                    <c:v>95.43963677320167</c:v>
                  </c:pt>
                  <c:pt idx="6">
                    <c:v>112.94451373483849</c:v>
                  </c:pt>
                  <c:pt idx="7">
                    <c:v>111.1607585054345</c:v>
                  </c:pt>
                  <c:pt idx="8">
                    <c:v>64.193522427702604</c:v>
                  </c:pt>
                  <c:pt idx="9">
                    <c:v>102.8631182095332</c:v>
                  </c:pt>
                  <c:pt idx="10">
                    <c:v>148.8742236289832</c:v>
                  </c:pt>
                  <c:pt idx="11">
                    <c:v>144.20729412034339</c:v>
                  </c:pt>
                  <c:pt idx="12">
                    <c:v>151.64602788060139</c:v>
                  </c:pt>
                  <c:pt idx="13">
                    <c:v>162.05026433286321</c:v>
                  </c:pt>
                </c:numCache>
              </c:numRef>
            </c:minus>
          </c:errBars>
          <c:xVal>
            <c:numRef>
              <c:f>'DI TV'!$C$38:$P$38</c:f>
              <c:numCache>
                <c:formatCode>####0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8</c:v>
                </c:pt>
                <c:pt idx="12">
                  <c:v>31</c:v>
                </c:pt>
                <c:pt idx="13">
                  <c:v>35</c:v>
                </c:pt>
              </c:numCache>
            </c:numRef>
          </c:xVal>
          <c:yVal>
            <c:numRef>
              <c:f>'DI TV'!$C$39:$P$39</c:f>
              <c:numCache>
                <c:formatCode>####0.00</c:formatCode>
                <c:ptCount val="14"/>
                <c:pt idx="0">
                  <c:v>456.66044950000003</c:v>
                </c:pt>
                <c:pt idx="1">
                  <c:v>534.57424849999995</c:v>
                </c:pt>
                <c:pt idx="2">
                  <c:v>616.18430475000002</c:v>
                </c:pt>
                <c:pt idx="3">
                  <c:v>661.21274374999996</c:v>
                </c:pt>
                <c:pt idx="4">
                  <c:v>756.53000175</c:v>
                </c:pt>
                <c:pt idx="5">
                  <c:v>742.08040574999995</c:v>
                </c:pt>
                <c:pt idx="6">
                  <c:v>792.84623249999993</c:v>
                </c:pt>
                <c:pt idx="7">
                  <c:v>844.06335800000011</c:v>
                </c:pt>
                <c:pt idx="8">
                  <c:v>856.60842675000004</c:v>
                </c:pt>
                <c:pt idx="9">
                  <c:v>936.15973050000002</c:v>
                </c:pt>
                <c:pt idx="10">
                  <c:v>1062.2783187499999</c:v>
                </c:pt>
                <c:pt idx="11">
                  <c:v>1073.8879117500001</c:v>
                </c:pt>
                <c:pt idx="12">
                  <c:v>1120.2869479999999</c:v>
                </c:pt>
                <c:pt idx="13">
                  <c:v>1272.610473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D174-1A40-9B40-51FD0637116D}"/>
            </c:ext>
          </c:extLst>
        </c:ser>
        <c:ser>
          <c:idx val="1"/>
          <c:order val="1"/>
          <c:tx>
            <c:strRef>
              <c:f>'DI TV'!$B$40</c:f>
              <c:strCache>
                <c:ptCount val="1"/>
                <c:pt idx="0">
                  <c:v>EFM19  Palbociclib 100 mg/kg QD</c:v>
                </c:pt>
              </c:strCache>
            </c:strRef>
          </c:tx>
          <c:spPr>
            <a:ln w="19050" cmpd="sng"/>
          </c:spPr>
          <c:marker>
            <c:spPr>
              <a:ln w="19050" cmpd="sng"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I TV'!$C$50:$P$50</c:f>
                <c:numCache>
                  <c:formatCode>General</c:formatCode>
                  <c:ptCount val="14"/>
                  <c:pt idx="0">
                    <c:v>133.03642696922631</c:v>
                  </c:pt>
                  <c:pt idx="1">
                    <c:v>103.1364896083026</c:v>
                  </c:pt>
                  <c:pt idx="2">
                    <c:v>60.539253253649278</c:v>
                  </c:pt>
                  <c:pt idx="3">
                    <c:v>37.845583524699528</c:v>
                  </c:pt>
                  <c:pt idx="4">
                    <c:v>30.866350725050111</c:v>
                  </c:pt>
                  <c:pt idx="5">
                    <c:v>37.476297639024267</c:v>
                  </c:pt>
                  <c:pt idx="6">
                    <c:v>38.073933136285397</c:v>
                  </c:pt>
                  <c:pt idx="7">
                    <c:v>34.5325235586131</c:v>
                  </c:pt>
                  <c:pt idx="8">
                    <c:v>36.564679765127188</c:v>
                  </c:pt>
                  <c:pt idx="9">
                    <c:v>44.595043448254678</c:v>
                  </c:pt>
                  <c:pt idx="10">
                    <c:v>38.447761277177271</c:v>
                  </c:pt>
                  <c:pt idx="11">
                    <c:v>39.193887727254094</c:v>
                  </c:pt>
                  <c:pt idx="12">
                    <c:v>35.954500201794268</c:v>
                  </c:pt>
                  <c:pt idx="13">
                    <c:v>37.064224652842533</c:v>
                  </c:pt>
                </c:numCache>
              </c:numRef>
            </c:plus>
            <c:minus>
              <c:numRef>
                <c:f>'DI TV'!$C$50:$P$50</c:f>
                <c:numCache>
                  <c:formatCode>General</c:formatCode>
                  <c:ptCount val="14"/>
                  <c:pt idx="0">
                    <c:v>133.03642696922631</c:v>
                  </c:pt>
                  <c:pt idx="1">
                    <c:v>103.1364896083026</c:v>
                  </c:pt>
                  <c:pt idx="2">
                    <c:v>60.539253253649278</c:v>
                  </c:pt>
                  <c:pt idx="3">
                    <c:v>37.845583524699528</c:v>
                  </c:pt>
                  <c:pt idx="4">
                    <c:v>30.866350725050111</c:v>
                  </c:pt>
                  <c:pt idx="5">
                    <c:v>37.476297639024267</c:v>
                  </c:pt>
                  <c:pt idx="6">
                    <c:v>38.073933136285397</c:v>
                  </c:pt>
                  <c:pt idx="7">
                    <c:v>34.5325235586131</c:v>
                  </c:pt>
                  <c:pt idx="8">
                    <c:v>36.564679765127188</c:v>
                  </c:pt>
                  <c:pt idx="9">
                    <c:v>44.595043448254678</c:v>
                  </c:pt>
                  <c:pt idx="10">
                    <c:v>38.447761277177271</c:v>
                  </c:pt>
                  <c:pt idx="11">
                    <c:v>39.193887727254094</c:v>
                  </c:pt>
                  <c:pt idx="12">
                    <c:v>35.954500201794268</c:v>
                  </c:pt>
                  <c:pt idx="13">
                    <c:v>37.064224652842533</c:v>
                  </c:pt>
                </c:numCache>
              </c:numRef>
            </c:minus>
          </c:errBars>
          <c:xVal>
            <c:numRef>
              <c:f>'DI TV'!$C$38:$P$38</c:f>
              <c:numCache>
                <c:formatCode>####0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8</c:v>
                </c:pt>
                <c:pt idx="12">
                  <c:v>31</c:v>
                </c:pt>
                <c:pt idx="13">
                  <c:v>35</c:v>
                </c:pt>
              </c:numCache>
            </c:numRef>
          </c:xVal>
          <c:yVal>
            <c:numRef>
              <c:f>'DI TV'!$C$40:$P$40</c:f>
              <c:numCache>
                <c:formatCode>####0.00</c:formatCode>
                <c:ptCount val="14"/>
                <c:pt idx="0">
                  <c:v>467.86459724999997</c:v>
                </c:pt>
                <c:pt idx="1">
                  <c:v>463.66019575000001</c:v>
                </c:pt>
                <c:pt idx="2">
                  <c:v>468.59903924999998</c:v>
                </c:pt>
                <c:pt idx="3">
                  <c:v>466.190065</c:v>
                </c:pt>
                <c:pt idx="4">
                  <c:v>441.05273075000002</c:v>
                </c:pt>
                <c:pt idx="5">
                  <c:v>438.792464</c:v>
                </c:pt>
                <c:pt idx="6">
                  <c:v>412.5783505</c:v>
                </c:pt>
                <c:pt idx="7">
                  <c:v>396.798496</c:v>
                </c:pt>
                <c:pt idx="8">
                  <c:v>388.53967725000001</c:v>
                </c:pt>
                <c:pt idx="9">
                  <c:v>377.93085875000003</c:v>
                </c:pt>
                <c:pt idx="10">
                  <c:v>346.484286</c:v>
                </c:pt>
                <c:pt idx="11">
                  <c:v>313.31815799999998</c:v>
                </c:pt>
                <c:pt idx="12">
                  <c:v>296.30452500000001</c:v>
                </c:pt>
                <c:pt idx="13">
                  <c:v>302.67588725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D174-1A40-9B40-51FD0637116D}"/>
            </c:ext>
          </c:extLst>
        </c:ser>
        <c:ser>
          <c:idx val="2"/>
          <c:order val="2"/>
          <c:tx>
            <c:strRef>
              <c:f>'DI TV'!$B$41</c:f>
              <c:strCache>
                <c:ptCount val="1"/>
                <c:pt idx="0">
                  <c:v>EFM19-PR Vehice Control</c:v>
                </c:pt>
              </c:strCache>
            </c:strRef>
          </c:tx>
          <c:spPr>
            <a:ln w="19050" cmpd="sng"/>
          </c:spPr>
          <c:marker>
            <c:spPr>
              <a:ln w="19050" cmpd="sng"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I TV'!$C$51:$P$51</c:f>
                <c:numCache>
                  <c:formatCode>General</c:formatCode>
                  <c:ptCount val="14"/>
                  <c:pt idx="0">
                    <c:v>20.357690631471549</c:v>
                  </c:pt>
                  <c:pt idx="1">
                    <c:v>25.366325051754739</c:v>
                  </c:pt>
                  <c:pt idx="2">
                    <c:v>27.867559591698399</c:v>
                  </c:pt>
                  <c:pt idx="3">
                    <c:v>30.615244840240418</c:v>
                  </c:pt>
                  <c:pt idx="4">
                    <c:v>35.405131261716583</c:v>
                  </c:pt>
                  <c:pt idx="5">
                    <c:v>31.769400875887111</c:v>
                  </c:pt>
                  <c:pt idx="6">
                    <c:v>36.297428526814343</c:v>
                  </c:pt>
                  <c:pt idx="7">
                    <c:v>38.769524024822168</c:v>
                  </c:pt>
                  <c:pt idx="8">
                    <c:v>53.245195090570959</c:v>
                  </c:pt>
                  <c:pt idx="9">
                    <c:v>58.633572975859302</c:v>
                  </c:pt>
                  <c:pt idx="10">
                    <c:v>68.89113136612464</c:v>
                  </c:pt>
                  <c:pt idx="11">
                    <c:v>77.720709522170225</c:v>
                  </c:pt>
                  <c:pt idx="12">
                    <c:v>87.391259716460908</c:v>
                  </c:pt>
                  <c:pt idx="13">
                    <c:v>133.2221945162967</c:v>
                  </c:pt>
                </c:numCache>
              </c:numRef>
            </c:plus>
            <c:minus>
              <c:numRef>
                <c:f>'DI TV'!$C$51:$P$51</c:f>
                <c:numCache>
                  <c:formatCode>General</c:formatCode>
                  <c:ptCount val="14"/>
                  <c:pt idx="0">
                    <c:v>20.357690631471549</c:v>
                  </c:pt>
                  <c:pt idx="1">
                    <c:v>25.366325051754739</c:v>
                  </c:pt>
                  <c:pt idx="2">
                    <c:v>27.867559591698399</c:v>
                  </c:pt>
                  <c:pt idx="3">
                    <c:v>30.615244840240418</c:v>
                  </c:pt>
                  <c:pt idx="4">
                    <c:v>35.405131261716583</c:v>
                  </c:pt>
                  <c:pt idx="5">
                    <c:v>31.769400875887111</c:v>
                  </c:pt>
                  <c:pt idx="6">
                    <c:v>36.297428526814343</c:v>
                  </c:pt>
                  <c:pt idx="7">
                    <c:v>38.769524024822168</c:v>
                  </c:pt>
                  <c:pt idx="8">
                    <c:v>53.245195090570959</c:v>
                  </c:pt>
                  <c:pt idx="9">
                    <c:v>58.633572975859302</c:v>
                  </c:pt>
                  <c:pt idx="10">
                    <c:v>68.89113136612464</c:v>
                  </c:pt>
                  <c:pt idx="11">
                    <c:v>77.720709522170225</c:v>
                  </c:pt>
                  <c:pt idx="12">
                    <c:v>87.391259716460908</c:v>
                  </c:pt>
                  <c:pt idx="13">
                    <c:v>133.2221945162967</c:v>
                  </c:pt>
                </c:numCache>
              </c:numRef>
            </c:minus>
          </c:errBars>
          <c:xVal>
            <c:numRef>
              <c:f>'DI TV'!$C$38:$P$38</c:f>
              <c:numCache>
                <c:formatCode>####0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8</c:v>
                </c:pt>
                <c:pt idx="12">
                  <c:v>31</c:v>
                </c:pt>
                <c:pt idx="13">
                  <c:v>35</c:v>
                </c:pt>
              </c:numCache>
            </c:numRef>
          </c:xVal>
          <c:yVal>
            <c:numRef>
              <c:f>'DI TV'!$C$41:$P$41</c:f>
              <c:numCache>
                <c:formatCode>####0.00</c:formatCode>
                <c:ptCount val="14"/>
                <c:pt idx="0">
                  <c:v>403.84769788888877</c:v>
                </c:pt>
                <c:pt idx="1">
                  <c:v>479.79910255555558</c:v>
                </c:pt>
                <c:pt idx="2">
                  <c:v>524.40000511111111</c:v>
                </c:pt>
                <c:pt idx="3">
                  <c:v>572.40383444444444</c:v>
                </c:pt>
                <c:pt idx="4">
                  <c:v>622.78296266666655</c:v>
                </c:pt>
                <c:pt idx="5">
                  <c:v>672.61049788888886</c:v>
                </c:pt>
                <c:pt idx="6">
                  <c:v>749.52907155555545</c:v>
                </c:pt>
                <c:pt idx="7">
                  <c:v>788.58645500000011</c:v>
                </c:pt>
                <c:pt idx="8">
                  <c:v>866.75759277777775</c:v>
                </c:pt>
                <c:pt idx="9">
                  <c:v>916.36368966666657</c:v>
                </c:pt>
                <c:pt idx="10">
                  <c:v>940.1652509999999</c:v>
                </c:pt>
                <c:pt idx="11">
                  <c:v>1009.595675888889</c:v>
                </c:pt>
                <c:pt idx="12">
                  <c:v>1037.4687333333329</c:v>
                </c:pt>
                <c:pt idx="13">
                  <c:v>1102.342722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D174-1A40-9B40-51FD0637116D}"/>
            </c:ext>
          </c:extLst>
        </c:ser>
        <c:ser>
          <c:idx val="3"/>
          <c:order val="3"/>
          <c:tx>
            <c:strRef>
              <c:f>'DI TV'!$B$42</c:f>
              <c:strCache>
                <c:ptCount val="1"/>
                <c:pt idx="0">
                  <c:v>EFM19-PR Palbociclib 100 mg/kg QD</c:v>
                </c:pt>
              </c:strCache>
            </c:strRef>
          </c:tx>
          <c:spPr>
            <a:ln w="19050" cmpd="sng"/>
          </c:spPr>
          <c:marker>
            <c:spPr>
              <a:ln w="19050" cmpd="sng"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DI TV'!$C$52:$P$52</c:f>
                <c:numCache>
                  <c:formatCode>General</c:formatCode>
                  <c:ptCount val="14"/>
                  <c:pt idx="0">
                    <c:v>19.48338022232042</c:v>
                  </c:pt>
                  <c:pt idx="1">
                    <c:v>22.925097344310078</c:v>
                  </c:pt>
                  <c:pt idx="2">
                    <c:v>28.725924835797091</c:v>
                  </c:pt>
                  <c:pt idx="3">
                    <c:v>31.546966955964919</c:v>
                  </c:pt>
                  <c:pt idx="4">
                    <c:v>38.769701560982227</c:v>
                  </c:pt>
                  <c:pt idx="5">
                    <c:v>49.166948842014619</c:v>
                  </c:pt>
                  <c:pt idx="6">
                    <c:v>52.345334417600412</c:v>
                  </c:pt>
                  <c:pt idx="7">
                    <c:v>60.562074298373673</c:v>
                  </c:pt>
                  <c:pt idx="8">
                    <c:v>67.005568652039585</c:v>
                  </c:pt>
                  <c:pt idx="9">
                    <c:v>79.070809040846882</c:v>
                  </c:pt>
                  <c:pt idx="10">
                    <c:v>77.764597686078645</c:v>
                  </c:pt>
                  <c:pt idx="11">
                    <c:v>84.035324723619382</c:v>
                  </c:pt>
                  <c:pt idx="12">
                    <c:v>87.134978069678994</c:v>
                  </c:pt>
                  <c:pt idx="13">
                    <c:v>135.52842304909919</c:v>
                  </c:pt>
                </c:numCache>
              </c:numRef>
            </c:plus>
            <c:minus>
              <c:numRef>
                <c:f>'DI TV'!$C$52:$P$52</c:f>
                <c:numCache>
                  <c:formatCode>General</c:formatCode>
                  <c:ptCount val="14"/>
                  <c:pt idx="0">
                    <c:v>19.48338022232042</c:v>
                  </c:pt>
                  <c:pt idx="1">
                    <c:v>22.925097344310078</c:v>
                  </c:pt>
                  <c:pt idx="2">
                    <c:v>28.725924835797091</c:v>
                  </c:pt>
                  <c:pt idx="3">
                    <c:v>31.546966955964919</c:v>
                  </c:pt>
                  <c:pt idx="4">
                    <c:v>38.769701560982227</c:v>
                  </c:pt>
                  <c:pt idx="5">
                    <c:v>49.166948842014619</c:v>
                  </c:pt>
                  <c:pt idx="6">
                    <c:v>52.345334417600412</c:v>
                  </c:pt>
                  <c:pt idx="7">
                    <c:v>60.562074298373673</c:v>
                  </c:pt>
                  <c:pt idx="8">
                    <c:v>67.005568652039585</c:v>
                  </c:pt>
                  <c:pt idx="9">
                    <c:v>79.070809040846882</c:v>
                  </c:pt>
                  <c:pt idx="10">
                    <c:v>77.764597686078645</c:v>
                  </c:pt>
                  <c:pt idx="11">
                    <c:v>84.035324723619382</c:v>
                  </c:pt>
                  <c:pt idx="12">
                    <c:v>87.134978069678994</c:v>
                  </c:pt>
                  <c:pt idx="13">
                    <c:v>135.52842304909919</c:v>
                  </c:pt>
                </c:numCache>
              </c:numRef>
            </c:minus>
          </c:errBars>
          <c:xVal>
            <c:numRef>
              <c:f>'DI TV'!$C$38:$P$38</c:f>
              <c:numCache>
                <c:formatCode>####0</c:formatCode>
                <c:ptCount val="14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8</c:v>
                </c:pt>
                <c:pt idx="4">
                  <c:v>10</c:v>
                </c:pt>
                <c:pt idx="5">
                  <c:v>13</c:v>
                </c:pt>
                <c:pt idx="6">
                  <c:v>15</c:v>
                </c:pt>
                <c:pt idx="7">
                  <c:v>17</c:v>
                </c:pt>
                <c:pt idx="8">
                  <c:v>20</c:v>
                </c:pt>
                <c:pt idx="9">
                  <c:v>22</c:v>
                </c:pt>
                <c:pt idx="10">
                  <c:v>24</c:v>
                </c:pt>
                <c:pt idx="11">
                  <c:v>28</c:v>
                </c:pt>
                <c:pt idx="12">
                  <c:v>31</c:v>
                </c:pt>
                <c:pt idx="13">
                  <c:v>35</c:v>
                </c:pt>
              </c:numCache>
            </c:numRef>
          </c:xVal>
          <c:yVal>
            <c:numRef>
              <c:f>'DI TV'!$C$42:$P$42</c:f>
              <c:numCache>
                <c:formatCode>####0.00</c:formatCode>
                <c:ptCount val="14"/>
                <c:pt idx="0">
                  <c:v>418.41925744444438</c:v>
                </c:pt>
                <c:pt idx="1">
                  <c:v>430.38207811111113</c:v>
                </c:pt>
                <c:pt idx="2">
                  <c:v>482.03084255555552</c:v>
                </c:pt>
                <c:pt idx="3">
                  <c:v>526.60259555555558</c:v>
                </c:pt>
                <c:pt idx="4">
                  <c:v>536.52846211111114</c:v>
                </c:pt>
                <c:pt idx="5">
                  <c:v>552.7305213333334</c:v>
                </c:pt>
                <c:pt idx="6">
                  <c:v>585.33589377777776</c:v>
                </c:pt>
                <c:pt idx="7">
                  <c:v>616.84772155555538</c:v>
                </c:pt>
                <c:pt idx="8">
                  <c:v>679.5592195555555</c:v>
                </c:pt>
                <c:pt idx="9">
                  <c:v>718.07956922222218</c:v>
                </c:pt>
                <c:pt idx="10">
                  <c:v>720.92243777777765</c:v>
                </c:pt>
                <c:pt idx="11">
                  <c:v>765.29534000000001</c:v>
                </c:pt>
                <c:pt idx="12">
                  <c:v>790.29710699999998</c:v>
                </c:pt>
                <c:pt idx="13">
                  <c:v>901.393402222222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D174-1A40-9B40-51FD063711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19715320"/>
        <c:axId val="-2069881224"/>
      </c:scatterChart>
      <c:valAx>
        <c:axId val="2119715320"/>
        <c:scaling>
          <c:orientation val="minMax"/>
          <c:max val="35"/>
        </c:scaling>
        <c:delete val="0"/>
        <c:axPos val="b"/>
        <c:numFmt formatCode="####0" sourceLinked="1"/>
        <c:majorTickMark val="out"/>
        <c:minorTickMark val="none"/>
        <c:tickLblPos val="nextTo"/>
        <c:crossAx val="-2069881224"/>
        <c:crosses val="autoZero"/>
        <c:crossBetween val="midCat"/>
        <c:majorUnit val="5"/>
      </c:valAx>
      <c:valAx>
        <c:axId val="-2069881224"/>
        <c:scaling>
          <c:orientation val="minMax"/>
        </c:scaling>
        <c:delete val="0"/>
        <c:axPos val="l"/>
        <c:numFmt formatCode="#,##0" sourceLinked="0"/>
        <c:majorTickMark val="out"/>
        <c:minorTickMark val="none"/>
        <c:tickLblPos val="nextTo"/>
        <c:crossAx val="211971532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1452513966480404"/>
          <c:y val="0.27919868849201401"/>
          <c:w val="0.38361266294227198"/>
          <c:h val="0.365892843836161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000000"/>
              </a:solidFill>
            </c:spPr>
            <c:extLst>
              <c:ext xmlns:c16="http://schemas.microsoft.com/office/drawing/2014/chart" uri="{C3380CC4-5D6E-409C-BE32-E72D297353CC}">
                <c16:uniqueId val="{00000001-14E5-1642-BEEF-6559E7F4E3AD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2"/>
              </a:solidFill>
            </c:spPr>
            <c:extLst>
              <c:ext xmlns:c16="http://schemas.microsoft.com/office/drawing/2014/chart" uri="{C3380CC4-5D6E-409C-BE32-E72D297353CC}">
                <c16:uniqueId val="{00000003-14E5-1642-BEEF-6559E7F4E3AD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3"/>
              </a:solidFill>
            </c:spPr>
            <c:extLst>
              <c:ext xmlns:c16="http://schemas.microsoft.com/office/drawing/2014/chart" uri="{C3380CC4-5D6E-409C-BE32-E72D297353CC}">
                <c16:uniqueId val="{00000005-14E5-1642-BEEF-6559E7F4E3AD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4"/>
              </a:solidFill>
            </c:spPr>
            <c:extLst>
              <c:ext xmlns:c16="http://schemas.microsoft.com/office/drawing/2014/chart" uri="{C3380CC4-5D6E-409C-BE32-E72D297353CC}">
                <c16:uniqueId val="{00000007-14E5-1642-BEEF-6559E7F4E3AD}"/>
              </c:ext>
            </c:extLst>
          </c:dPt>
          <c:errBars>
            <c:errBarType val="plus"/>
            <c:errValType val="cust"/>
            <c:noEndCap val="0"/>
            <c:plus>
              <c:numRef>
                <c:f>'DI TV'!$P$49:$P$52</c:f>
                <c:numCache>
                  <c:formatCode>General</c:formatCode>
                  <c:ptCount val="4"/>
                  <c:pt idx="0">
                    <c:v>162.05026433286321</c:v>
                  </c:pt>
                  <c:pt idx="1">
                    <c:v>37.064224652842533</c:v>
                  </c:pt>
                  <c:pt idx="2">
                    <c:v>133.2221945162967</c:v>
                  </c:pt>
                  <c:pt idx="3">
                    <c:v>135.528423049099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DI TV'!$B$39:$B$42</c:f>
              <c:strCache>
                <c:ptCount val="4"/>
                <c:pt idx="0">
                  <c:v>EFM19 Vehicle Control</c:v>
                </c:pt>
                <c:pt idx="1">
                  <c:v>EFM19  Palbociclib 100 mg/kg QD</c:v>
                </c:pt>
                <c:pt idx="2">
                  <c:v>EFM19-PR Vehice Control</c:v>
                </c:pt>
                <c:pt idx="3">
                  <c:v>EFM19-PR Palbociclib 100 mg/kg QD</c:v>
                </c:pt>
              </c:strCache>
            </c:strRef>
          </c:cat>
          <c:val>
            <c:numRef>
              <c:f>'DI TV'!$Q$39:$Q$42</c:f>
              <c:numCache>
                <c:formatCode>0.00</c:formatCode>
                <c:ptCount val="4"/>
                <c:pt idx="0">
                  <c:v>815.95002424999996</c:v>
                </c:pt>
                <c:pt idx="1">
                  <c:v>-165.18870999999999</c:v>
                </c:pt>
                <c:pt idx="2">
                  <c:v>698.49502411111121</c:v>
                </c:pt>
                <c:pt idx="3">
                  <c:v>482.974144777778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14E5-1642-BEEF-6559E7F4E3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2689688"/>
        <c:axId val="2120841912"/>
      </c:barChart>
      <c:catAx>
        <c:axId val="21126896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low"/>
        <c:crossAx val="2120841912"/>
        <c:crosses val="autoZero"/>
        <c:auto val="1"/>
        <c:lblAlgn val="ctr"/>
        <c:lblOffset val="100"/>
        <c:noMultiLvlLbl val="0"/>
      </c:catAx>
      <c:valAx>
        <c:axId val="2120841912"/>
        <c:scaling>
          <c:orientation val="minMax"/>
          <c:min val="-200"/>
        </c:scaling>
        <c:delete val="0"/>
        <c:axPos val="l"/>
        <c:numFmt formatCode="0" sourceLinked="0"/>
        <c:majorTickMark val="out"/>
        <c:minorTickMark val="none"/>
        <c:tickLblPos val="nextTo"/>
        <c:crossAx val="21126896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162" y="2130426"/>
            <a:ext cx="10360501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324" y="3886200"/>
            <a:ext cx="8532178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702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5007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780415" y="274639"/>
            <a:ext cx="3654531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2589" y="274639"/>
            <a:ext cx="1076468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4867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14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2833" y="4406901"/>
            <a:ext cx="10360501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2833" y="2906713"/>
            <a:ext cx="10360501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460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2589" y="1600201"/>
            <a:ext cx="7209606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5341" y="1600201"/>
            <a:ext cx="720960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3564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441" y="274638"/>
            <a:ext cx="10969943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441" y="1535113"/>
            <a:ext cx="5385514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441" y="2174875"/>
            <a:ext cx="5385514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1754" y="1535113"/>
            <a:ext cx="538763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1754" y="2174875"/>
            <a:ext cx="538763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9769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718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534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442" y="273050"/>
            <a:ext cx="4010039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5492" y="273051"/>
            <a:ext cx="6813892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442" y="1435101"/>
            <a:ext cx="4010039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10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095" y="4800600"/>
            <a:ext cx="7313295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095" y="612775"/>
            <a:ext cx="7313295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095" y="5367338"/>
            <a:ext cx="7313295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651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441" y="274638"/>
            <a:ext cx="10969943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441" y="1600201"/>
            <a:ext cx="10969943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441" y="6356351"/>
            <a:ext cx="2844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F973E2-FD06-2541-A180-780742699581}" type="datetimeFigureOut">
              <a:rPr lang="en-US" smtClean="0"/>
              <a:t>12/21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4515" y="6356351"/>
            <a:ext cx="385979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5325" y="6356351"/>
            <a:ext cx="284405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75D265-1B63-DC45-8FF6-94EF2BE85D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0436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251521" y="1047837"/>
            <a:ext cx="11509332" cy="4527554"/>
            <a:chOff x="441526" y="1415972"/>
            <a:chExt cx="11509332" cy="4527554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17744567"/>
                </p:ext>
              </p:extLst>
            </p:nvPr>
          </p:nvGraphicFramePr>
          <p:xfrm>
            <a:off x="890442" y="1415972"/>
            <a:ext cx="6819900" cy="40259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91163562"/>
                </p:ext>
              </p:extLst>
            </p:nvPr>
          </p:nvGraphicFramePr>
          <p:xfrm>
            <a:off x="8075267" y="1415972"/>
            <a:ext cx="3875591" cy="452755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 rot="16200000">
              <a:off x="6189968" y="3197538"/>
              <a:ext cx="341008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Mean </a:t>
              </a:r>
              <a:r>
                <a:rPr lang="en-US" sz="2000" dirty="0" err="1"/>
                <a:t>Δ</a:t>
              </a:r>
              <a:r>
                <a:rPr lang="en-US" sz="2000" dirty="0"/>
                <a:t> in Tumor Volume mm</a:t>
              </a:r>
              <a:r>
                <a:rPr lang="en-US" sz="2000" baseline="30000" dirty="0"/>
                <a:t>3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-505040" y="2871323"/>
              <a:ext cx="229324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Tumor Volume mm</a:t>
              </a:r>
              <a:r>
                <a:rPr lang="en-US" sz="2000" baseline="30000" dirty="0"/>
                <a:t>3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802694" y="5416328"/>
              <a:ext cx="58231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Days</a:t>
              </a:r>
            </a:p>
          </p:txBody>
        </p:sp>
      </p:grpSp>
      <p:sp>
        <p:nvSpPr>
          <p:cNvPr id="10" name="Rectangle 9">
            <a:extLst>
              <a:ext uri="{FF2B5EF4-FFF2-40B4-BE49-F238E27FC236}">
                <a16:creationId xmlns:a16="http://schemas.microsoft.com/office/drawing/2014/main" id="{9A4AC11A-702F-274C-801C-6DCC338C2828}"/>
              </a:ext>
            </a:extLst>
          </p:cNvPr>
          <p:cNvSpPr/>
          <p:nvPr/>
        </p:nvSpPr>
        <p:spPr>
          <a:xfrm>
            <a:off x="97141" y="5810163"/>
            <a:ext cx="1209168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: EFM19-PR cell line xenografts maintain resistance to palbociclib </a:t>
            </a:r>
            <a:r>
              <a:rPr lang="en-US" sz="1200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 vivo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rowth curves for EFM19 and EFM19-PR xenografts treated with 100 mg/kg palbociclib QD, 8 mice per arm (mean tumor volume ± SEM) and waterfall plot representing the change in tumor volume after 35 days of treatment.</a:t>
            </a:r>
            <a:endParaRPr lang="en-US" sz="1200" dirty="0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3D9FCB32-FFBB-1048-A3FC-DD44B1503A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96483"/>
            <a:ext cx="2515548" cy="750959"/>
          </a:xfrm>
        </p:spPr>
        <p:txBody>
          <a:bodyPr>
            <a:normAutofit/>
          </a:bodyPr>
          <a:lstStyle/>
          <a:p>
            <a:r>
              <a:rPr lang="en-US" sz="3200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4106830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68</Words>
  <Application>Microsoft Macintosh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Figure S2</vt:lpstr>
    </vt:vector>
  </TitlesOfParts>
  <Company>UCL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O'Brien</dc:creator>
  <cp:lastModifiedBy>O'Brien, Neil</cp:lastModifiedBy>
  <cp:revision>5</cp:revision>
  <dcterms:created xsi:type="dcterms:W3CDTF">2018-11-05T03:25:45Z</dcterms:created>
  <dcterms:modified xsi:type="dcterms:W3CDTF">2019-12-22T04:24:08Z</dcterms:modified>
</cp:coreProperties>
</file>